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2" d="100"/>
          <a:sy n="72" d="100"/>
        </p:scale>
        <p:origin x="-2344" y="9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303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46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296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756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822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31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917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860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944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043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256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A58C8-6B1E-124F-A39E-8628BD8F650A}" type="datetimeFigureOut">
              <a:rPr lang="en-US" smtClean="0"/>
              <a:t>09/0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C768B-1C0D-5F4A-A868-104119FA1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141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4" Type="http://schemas.openxmlformats.org/officeDocument/2006/relationships/image" Target="../media/image16.T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UVI00857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79" t="31005" r="21104" b="44596"/>
          <a:stretch/>
        </p:blipFill>
        <p:spPr>
          <a:xfrm>
            <a:off x="1349843" y="2434126"/>
            <a:ext cx="3649903" cy="994063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577608" y="1972873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pcDNA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204289" y="1972873"/>
            <a:ext cx="7119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GFP-</a:t>
            </a:r>
            <a:r>
              <a:rPr lang="en-US" sz="1000" dirty="0" err="1" smtClean="0">
                <a:latin typeface="Arial"/>
                <a:cs typeface="Arial"/>
              </a:rPr>
              <a:t>Fbn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562288" y="1972873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1719Y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879704" y="1972873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1564Y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205704" y="1972873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1720Y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35363" y="2236648"/>
            <a:ext cx="36500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M  1  2  3  4  M  1  2   3  4 M  1  2   3  4  M  1  2   3  4 M  1  2   3  4  M </a:t>
            </a:r>
          </a:p>
          <a:p>
            <a:endParaRPr lang="en-US" sz="1000" dirty="0"/>
          </a:p>
        </p:txBody>
      </p:sp>
      <p:sp>
        <p:nvSpPr>
          <p:cNvPr id="7" name="Right Brace 6"/>
          <p:cNvSpPr/>
          <p:nvPr/>
        </p:nvSpPr>
        <p:spPr>
          <a:xfrm rot="16200000">
            <a:off x="1849033" y="2047491"/>
            <a:ext cx="132492" cy="409871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8" name="Right Brace 7"/>
          <p:cNvSpPr/>
          <p:nvPr/>
        </p:nvSpPr>
        <p:spPr>
          <a:xfrm rot="16200000">
            <a:off x="2499413" y="2026784"/>
            <a:ext cx="132492" cy="45128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9" name="Right Brace 8"/>
          <p:cNvSpPr/>
          <p:nvPr/>
        </p:nvSpPr>
        <p:spPr>
          <a:xfrm rot="16200000">
            <a:off x="3159933" y="2018427"/>
            <a:ext cx="132492" cy="467999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0" name="Right Brace 9"/>
          <p:cNvSpPr/>
          <p:nvPr/>
        </p:nvSpPr>
        <p:spPr>
          <a:xfrm rot="16200000">
            <a:off x="3826768" y="2036427"/>
            <a:ext cx="132492" cy="431999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1" name="Right Brace 10"/>
          <p:cNvSpPr/>
          <p:nvPr/>
        </p:nvSpPr>
        <p:spPr>
          <a:xfrm rot="16200000">
            <a:off x="4495901" y="2018427"/>
            <a:ext cx="132492" cy="467999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pic>
        <p:nvPicPr>
          <p:cNvPr id="21" name="Picture 20" descr="UVI00857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79" t="54968" r="21104" b="20399"/>
          <a:stretch/>
        </p:blipFill>
        <p:spPr>
          <a:xfrm>
            <a:off x="1349843" y="3508117"/>
            <a:ext cx="3649903" cy="1003589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762768" y="2796245"/>
            <a:ext cx="5648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GAPDH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936845" y="3840047"/>
            <a:ext cx="390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GFP</a:t>
            </a:r>
            <a:endParaRPr lang="en-US" sz="1000" dirty="0"/>
          </a:p>
        </p:txBody>
      </p:sp>
      <p:sp>
        <p:nvSpPr>
          <p:cNvPr id="2" name="TextBox 1"/>
          <p:cNvSpPr txBox="1"/>
          <p:nvPr/>
        </p:nvSpPr>
        <p:spPr>
          <a:xfrm>
            <a:off x="4440272" y="8996775"/>
            <a:ext cx="17849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1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666042" y="5746212"/>
            <a:ext cx="5559170" cy="3046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1: </a:t>
            </a:r>
            <a:r>
              <a:rPr lang="en-GB" sz="1200" dirty="0"/>
              <a:t>Semi-quantitative RT-PCR analysis of transiently transfected HEK293T cells expressing GFP-</a:t>
            </a:r>
            <a:r>
              <a:rPr lang="en-GB" sz="1200" dirty="0" err="1"/>
              <a:t>Fbn</a:t>
            </a:r>
            <a:r>
              <a:rPr lang="en-GB" sz="1200" dirty="0"/>
              <a:t> variants that display intracellular retention were carried out as described previously (1) to show that transcript levels for these constructs are not markedly different to the wild-type form. Transfected cells were grown to 80% confluence in 25 cm</a:t>
            </a:r>
            <a:r>
              <a:rPr lang="en-GB" sz="1200" baseline="30000" dirty="0"/>
              <a:t>2</a:t>
            </a:r>
            <a:r>
              <a:rPr lang="en-GB" sz="1200" dirty="0"/>
              <a:t> tissue culture flasks and total RNA was extracted using the </a:t>
            </a:r>
            <a:r>
              <a:rPr lang="en-GB" sz="1200" dirty="0" err="1"/>
              <a:t>RNeasy</a:t>
            </a:r>
            <a:r>
              <a:rPr lang="en-GB" sz="1200" dirty="0"/>
              <a:t> Mini kit (</a:t>
            </a:r>
            <a:r>
              <a:rPr lang="en-GB" sz="1200" dirty="0" err="1"/>
              <a:t>Qiagen</a:t>
            </a:r>
            <a:r>
              <a:rPr lang="en-GB" sz="1200" dirty="0"/>
              <a:t>). Reverse transcription was carried out using the </a:t>
            </a:r>
            <a:r>
              <a:rPr lang="en-GB" sz="1200" dirty="0" err="1"/>
              <a:t>Omniscript</a:t>
            </a:r>
            <a:r>
              <a:rPr lang="en-GB" sz="1200" dirty="0"/>
              <a:t> RT kit (</a:t>
            </a:r>
            <a:r>
              <a:rPr lang="en-GB" sz="1200" dirty="0" err="1"/>
              <a:t>Qiagen</a:t>
            </a:r>
            <a:r>
              <a:rPr lang="en-GB" sz="1200" dirty="0"/>
              <a:t>) and primers GAPDH_1002r (5'-CTTGGAGGCCATGTGGGCC-3') and </a:t>
            </a:r>
            <a:r>
              <a:rPr lang="en-GB" sz="1200" dirty="0" err="1"/>
              <a:t>GFPrev</a:t>
            </a:r>
            <a:r>
              <a:rPr lang="en-GB" sz="1200" dirty="0"/>
              <a:t> (5'-CTTGTACAGCTCGTCCATGC-3') for first strand synthesis of GAPDH and GFP-</a:t>
            </a:r>
            <a:r>
              <a:rPr lang="en-GB" sz="1200" dirty="0" err="1"/>
              <a:t>Fbn</a:t>
            </a:r>
            <a:r>
              <a:rPr lang="en-GB" sz="1200" dirty="0"/>
              <a:t> transcripts, respectively. GAPDH (629 </a:t>
            </a:r>
            <a:r>
              <a:rPr lang="en-GB" sz="1200" dirty="0" err="1"/>
              <a:t>bp</a:t>
            </a:r>
            <a:r>
              <a:rPr lang="en-GB" sz="1200" dirty="0"/>
              <a:t>) and GFP (717 </a:t>
            </a:r>
            <a:r>
              <a:rPr lang="en-GB" sz="1200" dirty="0" err="1"/>
              <a:t>bp</a:t>
            </a:r>
            <a:r>
              <a:rPr lang="en-GB" sz="1200" dirty="0"/>
              <a:t>) fragments were then amplified using </a:t>
            </a:r>
            <a:r>
              <a:rPr lang="en-GB" sz="1200" dirty="0" err="1"/>
              <a:t>Taq</a:t>
            </a:r>
            <a:r>
              <a:rPr lang="en-GB" sz="1200" dirty="0"/>
              <a:t> DNA polymerase using primers combinations GAPDH_303f (5'-CTTCACCACCATGGAGAAGG-3') and GAPDH_932r (5'-ATGAGCTTGACAAAGTGGTCG-3'), and </a:t>
            </a:r>
            <a:r>
              <a:rPr lang="en-GB" sz="1200" dirty="0" err="1"/>
              <a:t>GFPfor</a:t>
            </a:r>
            <a:r>
              <a:rPr lang="en-GB" sz="1200" dirty="0"/>
              <a:t> (5'-ATGGTGAGCAAGGGCGAGC-3') and </a:t>
            </a:r>
            <a:r>
              <a:rPr lang="en-GB" sz="1200" dirty="0" err="1"/>
              <a:t>GFPrev</a:t>
            </a:r>
            <a:r>
              <a:rPr lang="en-GB" sz="1200" dirty="0"/>
              <a:t>, respectively. </a:t>
            </a:r>
            <a:r>
              <a:rPr lang="en-GB" sz="1200" b="1" dirty="0"/>
              <a:t>M</a:t>
            </a:r>
            <a:r>
              <a:rPr lang="en-GB" sz="1200" dirty="0"/>
              <a:t>: 100 </a:t>
            </a:r>
            <a:r>
              <a:rPr lang="en-GB" sz="1200" dirty="0" err="1"/>
              <a:t>bp</a:t>
            </a:r>
            <a:r>
              <a:rPr lang="en-GB" sz="1200" dirty="0"/>
              <a:t> ladder (New England </a:t>
            </a:r>
            <a:r>
              <a:rPr lang="en-GB" sz="1200" dirty="0" err="1"/>
              <a:t>Biolabs</a:t>
            </a:r>
            <a:r>
              <a:rPr lang="en-GB" sz="1200" dirty="0"/>
              <a:t> N3231S). </a:t>
            </a:r>
            <a:r>
              <a:rPr lang="en-GB" sz="1200" b="1" dirty="0"/>
              <a:t>1</a:t>
            </a:r>
            <a:r>
              <a:rPr lang="en-GB" sz="1200" dirty="0"/>
              <a:t>: control reactions set up without reverse transcriptase and amplified over 30 cycles. </a:t>
            </a:r>
            <a:r>
              <a:rPr lang="en-GB" sz="1200" b="1" dirty="0"/>
              <a:t>2, 3 and 4</a:t>
            </a:r>
            <a:r>
              <a:rPr lang="en-GB" sz="1200" dirty="0"/>
              <a:t>: reactions amplified over 20, 25 and 30 cycles, respectively.  </a:t>
            </a:r>
          </a:p>
          <a:p>
            <a:pPr algn="just"/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074462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0" descr="CB7269-0027.zvi - C=6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4769" y="4028937"/>
            <a:ext cx="1817476" cy="1440000"/>
          </a:xfrm>
          <a:prstGeom prst="rect">
            <a:avLst/>
          </a:prstGeom>
        </p:spPr>
      </p:pic>
      <p:pic>
        <p:nvPicPr>
          <p:cNvPr id="43" name="Picture 42" descr="CB7269-0024.zvi - C=6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233" y="5476082"/>
            <a:ext cx="1817476" cy="1440000"/>
          </a:xfrm>
          <a:prstGeom prst="rect">
            <a:avLst/>
          </a:prstGeom>
        </p:spPr>
      </p:pic>
      <p:pic>
        <p:nvPicPr>
          <p:cNvPr id="44" name="Picture 43" descr="CB7269-0033.zvi - C=6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4769" y="5476082"/>
            <a:ext cx="1817476" cy="1440000"/>
          </a:xfrm>
          <a:prstGeom prst="rect">
            <a:avLst/>
          </a:prstGeom>
        </p:spPr>
      </p:pic>
      <p:pic>
        <p:nvPicPr>
          <p:cNvPr id="45" name="Picture 44" descr="CB7269-0039.zvi - C=6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7041" y="5476082"/>
            <a:ext cx="1817476" cy="1440000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861233" y="1141603"/>
            <a:ext cx="1817476" cy="1440000"/>
            <a:chOff x="1659374" y="538999"/>
            <a:chExt cx="1817476" cy="1440000"/>
          </a:xfrm>
        </p:grpSpPr>
        <p:pic>
          <p:nvPicPr>
            <p:cNvPr id="14" name="Picture 13" descr="CB7269-0006.zvi - C=6.pn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59374" y="538999"/>
              <a:ext cx="1817476" cy="14400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659374" y="1732571"/>
              <a:ext cx="3817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/>
                  <a:cs typeface="Arial"/>
                </a:rPr>
                <a:t>WT</a:t>
              </a:r>
              <a:endParaRPr lang="en-US" sz="10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861233" y="2582861"/>
            <a:ext cx="1817476" cy="1440000"/>
            <a:chOff x="3482910" y="538999"/>
            <a:chExt cx="1817476" cy="1440000"/>
          </a:xfrm>
        </p:grpSpPr>
        <p:pic>
          <p:nvPicPr>
            <p:cNvPr id="15" name="Picture 14" descr="CB7269-0019.zvi - C=6.png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2910" y="538999"/>
              <a:ext cx="1817476" cy="14400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3482910" y="1732571"/>
              <a:ext cx="10375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/>
                  <a:cs typeface="Arial"/>
                </a:rPr>
                <a:t>C1564Y (MFS)</a:t>
              </a:r>
              <a:endParaRPr lang="en-US" sz="10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2684769" y="1141603"/>
            <a:ext cx="1817476" cy="1440000"/>
            <a:chOff x="1659374" y="1985075"/>
            <a:chExt cx="1817476" cy="1440000"/>
          </a:xfrm>
        </p:grpSpPr>
        <p:pic>
          <p:nvPicPr>
            <p:cNvPr id="16" name="Picture 15" descr="CB7269-0014.zvi - C=6.png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59374" y="1985075"/>
              <a:ext cx="1817476" cy="14400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1659374" y="3178647"/>
              <a:ext cx="10257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/>
                  <a:cs typeface="Arial"/>
                </a:rPr>
                <a:t>C1564S (SSS)</a:t>
              </a:r>
              <a:endParaRPr lang="en-US" sz="10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4507041" y="1141603"/>
            <a:ext cx="1817476" cy="1440000"/>
            <a:chOff x="3482910" y="1985075"/>
            <a:chExt cx="1817476" cy="1440000"/>
          </a:xfrm>
        </p:grpSpPr>
        <p:pic>
          <p:nvPicPr>
            <p:cNvPr id="17" name="Picture 16" descr="CB7269-0022.zvi - C=6.png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2910" y="1985075"/>
              <a:ext cx="1817476" cy="14400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3482910" y="3178647"/>
              <a:ext cx="10612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/>
                  <a:cs typeface="Arial"/>
                </a:rPr>
                <a:t>W1570C (SSS)</a:t>
              </a:r>
              <a:endParaRPr lang="en-US" sz="10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3791767" y="9061290"/>
            <a:ext cx="242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2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2684769" y="2582861"/>
            <a:ext cx="1817476" cy="1440000"/>
            <a:chOff x="2702949" y="3994341"/>
            <a:chExt cx="1817476" cy="1440000"/>
          </a:xfrm>
        </p:grpSpPr>
        <p:pic>
          <p:nvPicPr>
            <p:cNvPr id="38" name="Picture 37" descr="CB7269-0015.zvi - C=6.png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2949" y="3994341"/>
              <a:ext cx="1817476" cy="1440000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2702949" y="5184689"/>
              <a:ext cx="10375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  <a:latin typeface="Arial"/>
                  <a:cs typeface="Arial"/>
                </a:rPr>
                <a:t>C1719Y (MFS)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507041" y="2582861"/>
            <a:ext cx="1817476" cy="1440000"/>
            <a:chOff x="4525221" y="3994341"/>
            <a:chExt cx="1817476" cy="1440000"/>
          </a:xfrm>
        </p:grpSpPr>
        <p:pic>
          <p:nvPicPr>
            <p:cNvPr id="39" name="Picture 38" descr="CB7269-0019.zvi - C=6.png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25221" y="3994341"/>
              <a:ext cx="1817476" cy="1440000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4525221" y="5184689"/>
              <a:ext cx="10375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  <a:latin typeface="Arial"/>
                  <a:cs typeface="Arial"/>
                </a:rPr>
                <a:t>C1720Y (MFS)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861233" y="4028937"/>
            <a:ext cx="1817476" cy="1440000"/>
            <a:chOff x="879413" y="5440417"/>
            <a:chExt cx="1817476" cy="1440000"/>
          </a:xfrm>
        </p:grpSpPr>
        <p:pic>
          <p:nvPicPr>
            <p:cNvPr id="40" name="Picture 39" descr="CB7269-0013.zvi - C=6.png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9413" y="5440417"/>
              <a:ext cx="1817476" cy="1440000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879413" y="6630765"/>
              <a:ext cx="997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  <a:latin typeface="Arial"/>
                  <a:cs typeface="Arial"/>
                </a:rPr>
                <a:t>C1719W </a:t>
              </a:r>
              <a:r>
                <a:rPr lang="en-US" sz="1000" dirty="0" smtClean="0">
                  <a:solidFill>
                    <a:schemeClr val="bg1"/>
                  </a:solidFill>
                  <a:latin typeface="Arial"/>
                  <a:cs typeface="Arial"/>
                </a:rPr>
                <a:t>(GD)</a:t>
              </a:r>
              <a:endParaRPr lang="en-US" sz="10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2684769" y="5219285"/>
            <a:ext cx="9686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/>
                <a:cs typeface="Arial"/>
              </a:rPr>
              <a:t>G1762S </a:t>
            </a:r>
            <a:r>
              <a:rPr lang="en-US" sz="1000" dirty="0" smtClean="0">
                <a:solidFill>
                  <a:schemeClr val="bg1"/>
                </a:solidFill>
                <a:latin typeface="Arial"/>
                <a:cs typeface="Arial"/>
              </a:rPr>
              <a:t>(GD)</a:t>
            </a:r>
            <a:endParaRPr lang="en-US" sz="10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4507041" y="4028937"/>
            <a:ext cx="1817476" cy="1440000"/>
            <a:chOff x="4525221" y="5440417"/>
            <a:chExt cx="1817476" cy="1440000"/>
          </a:xfrm>
        </p:grpSpPr>
        <p:pic>
          <p:nvPicPr>
            <p:cNvPr id="42" name="Picture 41" descr="CB7269-0042.zvi - C=6.png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25221" y="5440417"/>
              <a:ext cx="1817476" cy="1440000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4525221" y="6630765"/>
              <a:ext cx="9614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  <a:latin typeface="Arial"/>
                  <a:cs typeface="Arial"/>
                </a:rPr>
                <a:t>Y1699D </a:t>
              </a:r>
              <a:r>
                <a:rPr lang="en-US" sz="1000" dirty="0" smtClean="0">
                  <a:solidFill>
                    <a:schemeClr val="bg1"/>
                  </a:solidFill>
                  <a:latin typeface="Arial"/>
                  <a:cs typeface="Arial"/>
                </a:rPr>
                <a:t>(GD)</a:t>
              </a:r>
              <a:endParaRPr lang="en-US" sz="10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861233" y="6666430"/>
            <a:ext cx="947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/>
                <a:cs typeface="Arial"/>
              </a:rPr>
              <a:t>D1758V </a:t>
            </a:r>
            <a:r>
              <a:rPr lang="en-US" sz="1000" dirty="0" smtClean="0">
                <a:solidFill>
                  <a:schemeClr val="bg1"/>
                </a:solidFill>
                <a:latin typeface="Arial"/>
                <a:cs typeface="Arial"/>
              </a:rPr>
              <a:t>(AD)</a:t>
            </a:r>
            <a:endParaRPr lang="en-US" sz="10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684769" y="6666430"/>
            <a:ext cx="947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/>
                <a:cs typeface="Arial"/>
              </a:rPr>
              <a:t>S1722C </a:t>
            </a:r>
            <a:r>
              <a:rPr lang="en-US" sz="1000" dirty="0" smtClean="0">
                <a:solidFill>
                  <a:schemeClr val="bg1"/>
                </a:solidFill>
                <a:latin typeface="Arial"/>
                <a:cs typeface="Arial"/>
              </a:rPr>
              <a:t>(AD)</a:t>
            </a:r>
            <a:endParaRPr lang="en-US" sz="10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507041" y="6666430"/>
            <a:ext cx="947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/>
                <a:cs typeface="Arial"/>
              </a:rPr>
              <a:t>Y1700C </a:t>
            </a:r>
            <a:r>
              <a:rPr lang="en-US" sz="1000" dirty="0" smtClean="0">
                <a:solidFill>
                  <a:schemeClr val="bg1"/>
                </a:solidFill>
                <a:latin typeface="Arial"/>
                <a:cs typeface="Arial"/>
              </a:rPr>
              <a:t>(AD)</a:t>
            </a:r>
            <a:endParaRPr lang="en-US" sz="10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61233" y="7289783"/>
            <a:ext cx="5237017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Figure S2: </a:t>
            </a:r>
            <a:endParaRPr lang="en-GB" sz="1000" dirty="0"/>
          </a:p>
          <a:p>
            <a:pPr algn="just"/>
            <a:r>
              <a:rPr lang="en-GB" sz="1000" dirty="0"/>
              <a:t>Anti-fibrillin-1 staining of </a:t>
            </a:r>
            <a:r>
              <a:rPr lang="en-GB" sz="1000" dirty="0" err="1"/>
              <a:t>cocultures</a:t>
            </a:r>
            <a:r>
              <a:rPr lang="en-GB" sz="1000" dirty="0"/>
              <a:t> shown in figure 3. FS2 fibroblasts were co-cultured for 5 days with HEK293T cells transiently transfected to express GFP-</a:t>
            </a:r>
            <a:r>
              <a:rPr lang="en-GB" sz="1000" dirty="0" err="1"/>
              <a:t>Fbn</a:t>
            </a:r>
            <a:r>
              <a:rPr lang="en-GB" sz="1000" dirty="0"/>
              <a:t> variants. Cells were fixed and stained for GFP (Figure 3) and fibrillin-1, using an antibody directed against the </a:t>
            </a:r>
            <a:r>
              <a:rPr lang="en-GB" sz="1000" dirty="0" err="1"/>
              <a:t>proline</a:t>
            </a:r>
            <a:r>
              <a:rPr lang="en-GB" sz="1000" dirty="0"/>
              <a:t>-rich region as described previously (1). No difference is seen in the wild-type fibrillin-1 network expressed by the FS2 in the mutant GFP-</a:t>
            </a:r>
            <a:r>
              <a:rPr lang="en-GB" sz="1000" dirty="0" err="1"/>
              <a:t>Fbn</a:t>
            </a:r>
            <a:r>
              <a:rPr lang="en-GB" sz="1000" dirty="0"/>
              <a:t> </a:t>
            </a:r>
            <a:r>
              <a:rPr lang="en-GB" sz="1000" dirty="0" err="1"/>
              <a:t>cocultures</a:t>
            </a:r>
            <a:r>
              <a:rPr lang="en-GB" sz="1000" dirty="0"/>
              <a:t> compared to the wild-type GFP-</a:t>
            </a:r>
            <a:r>
              <a:rPr lang="en-GB" sz="1000" dirty="0" err="1"/>
              <a:t>Fbn</a:t>
            </a:r>
            <a:r>
              <a:rPr lang="en-GB" sz="1000" dirty="0"/>
              <a:t> </a:t>
            </a:r>
            <a:r>
              <a:rPr lang="en-GB" sz="1000" dirty="0" err="1"/>
              <a:t>coculture</a:t>
            </a:r>
            <a:r>
              <a:rPr lang="en-GB" sz="1000" dirty="0" smtClean="0"/>
              <a:t>.</a:t>
            </a:r>
          </a:p>
          <a:p>
            <a:pPr algn="just"/>
            <a:endParaRPr lang="en-GB" sz="1000" dirty="0"/>
          </a:p>
          <a:p>
            <a:pPr algn="just"/>
            <a:r>
              <a:rPr lang="en-GB" sz="1000" dirty="0"/>
              <a:t>1	Jensen, S.A., </a:t>
            </a:r>
            <a:r>
              <a:rPr lang="en-GB" sz="1000" dirty="0" err="1"/>
              <a:t>Aspinall</a:t>
            </a:r>
            <a:r>
              <a:rPr lang="en-GB" sz="1000" dirty="0"/>
              <a:t>, G. and </a:t>
            </a:r>
            <a:r>
              <a:rPr lang="en-GB" sz="1000" dirty="0" err="1"/>
              <a:t>Handford</a:t>
            </a:r>
            <a:r>
              <a:rPr lang="en-GB" sz="1000" dirty="0"/>
              <a:t>, P.A. (2014) C-terminal </a:t>
            </a:r>
            <a:r>
              <a:rPr lang="en-GB" sz="1000" dirty="0" err="1"/>
              <a:t>propeptide</a:t>
            </a:r>
            <a:r>
              <a:rPr lang="en-GB" sz="1000" dirty="0"/>
              <a:t> is required for fibrillin-1 secretion and blocks premature assembly through linkage to domains cbEGF41-43. </a:t>
            </a:r>
            <a:r>
              <a:rPr lang="en-GB" sz="1000" i="1" dirty="0"/>
              <a:t>Proceedings of the National Academy of Sciences of the United States of America</a:t>
            </a:r>
            <a:r>
              <a:rPr lang="en-GB" sz="1000" dirty="0"/>
              <a:t>, </a:t>
            </a:r>
            <a:r>
              <a:rPr lang="en-GB" sz="1000" b="1" dirty="0"/>
              <a:t>111</a:t>
            </a:r>
            <a:r>
              <a:rPr lang="en-GB" sz="1000" dirty="0"/>
              <a:t>, 10155-10160.</a:t>
            </a:r>
          </a:p>
          <a:p>
            <a:pPr algn="just"/>
            <a:endParaRPr lang="en-US" sz="1000" dirty="0"/>
          </a:p>
          <a:p>
            <a:pPr algn="just"/>
            <a:endParaRPr lang="en-GB" sz="1000" dirty="0"/>
          </a:p>
          <a:p>
            <a:pPr algn="just"/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763896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169326" y="1308727"/>
            <a:ext cx="443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bn1</a:t>
            </a: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1106897" y="2229919"/>
            <a:ext cx="505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usion</a:t>
            </a:r>
            <a:endParaRPr lang="en-US" sz="1000" dirty="0"/>
          </a:p>
        </p:txBody>
      </p:sp>
      <p:grpSp>
        <p:nvGrpSpPr>
          <p:cNvPr id="41" name="Group 40"/>
          <p:cNvGrpSpPr/>
          <p:nvPr/>
        </p:nvGrpSpPr>
        <p:grpSpPr>
          <a:xfrm>
            <a:off x="1646826" y="547549"/>
            <a:ext cx="3313728" cy="509996"/>
            <a:chOff x="1446288" y="806556"/>
            <a:chExt cx="3313728" cy="509996"/>
          </a:xfrm>
        </p:grpSpPr>
        <p:grpSp>
          <p:nvGrpSpPr>
            <p:cNvPr id="8" name="Group 7"/>
            <p:cNvGrpSpPr/>
            <p:nvPr/>
          </p:nvGrpSpPr>
          <p:grpSpPr>
            <a:xfrm>
              <a:off x="1588533" y="806556"/>
              <a:ext cx="3151839" cy="246221"/>
              <a:chOff x="1302078" y="248109"/>
              <a:chExt cx="3151839" cy="246221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1302078" y="248109"/>
                <a:ext cx="6906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MSU-1.1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035331" y="248109"/>
                <a:ext cx="3817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WT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3144662" y="248109"/>
                <a:ext cx="6463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C1564Y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542007" y="248109"/>
                <a:ext cx="6480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C1564S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3770316" y="248109"/>
                <a:ext cx="6836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W1570C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1446288" y="1070331"/>
              <a:ext cx="33137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M  1  2  3  4 M 1  2   3  4 M 1  2   3  4 M 1  2   3  4 M 1  2   3  4</a:t>
              </a:r>
              <a:endParaRPr lang="en-US" sz="1000" dirty="0"/>
            </a:p>
          </p:txBody>
        </p:sp>
        <p:sp>
          <p:nvSpPr>
            <p:cNvPr id="16" name="Right Brace 15"/>
            <p:cNvSpPr/>
            <p:nvPr/>
          </p:nvSpPr>
          <p:spPr>
            <a:xfrm rot="16200000">
              <a:off x="1859958" y="881174"/>
              <a:ext cx="132492" cy="409871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7" name="Right Brace 16"/>
            <p:cNvSpPr/>
            <p:nvPr/>
          </p:nvSpPr>
          <p:spPr>
            <a:xfrm rot="16200000">
              <a:off x="2465933" y="860467"/>
              <a:ext cx="132492" cy="451285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8" name="Right Brace 17"/>
            <p:cNvSpPr/>
            <p:nvPr/>
          </p:nvSpPr>
          <p:spPr>
            <a:xfrm rot="16200000">
              <a:off x="3090929" y="852110"/>
              <a:ext cx="132492" cy="467999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9" name="Right Brace 18"/>
            <p:cNvSpPr/>
            <p:nvPr/>
          </p:nvSpPr>
          <p:spPr>
            <a:xfrm rot="16200000">
              <a:off x="3704478" y="870110"/>
              <a:ext cx="132492" cy="431999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0" name="Right Brace 19"/>
            <p:cNvSpPr/>
            <p:nvPr/>
          </p:nvSpPr>
          <p:spPr>
            <a:xfrm rot="16200000">
              <a:off x="4328968" y="870110"/>
              <a:ext cx="132492" cy="431999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759887" y="534783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A.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24" name="Picture 23" descr="TB4 RTPCRs 230614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35" t="27993" r="7402" b="43626"/>
          <a:stretch/>
        </p:blipFill>
        <p:spPr>
          <a:xfrm>
            <a:off x="1608561" y="1007455"/>
            <a:ext cx="3383666" cy="880247"/>
          </a:xfrm>
          <a:prstGeom prst="rect">
            <a:avLst/>
          </a:prstGeom>
        </p:spPr>
      </p:pic>
      <p:pic>
        <p:nvPicPr>
          <p:cNvPr id="25" name="Picture 24" descr="TB4 RTPCRs 230614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5" t="54980" r="8282" b="15541"/>
          <a:stretch/>
        </p:blipFill>
        <p:spPr>
          <a:xfrm>
            <a:off x="1608561" y="1921122"/>
            <a:ext cx="3383666" cy="914283"/>
          </a:xfrm>
          <a:prstGeom prst="rect">
            <a:avLst/>
          </a:prstGeom>
        </p:spPr>
      </p:pic>
      <p:pic>
        <p:nvPicPr>
          <p:cNvPr id="26" name="Picture 25" descr="TB5_endo_RTPCRs.TI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01" t="29147" r="8317" b="41751"/>
          <a:stretch/>
        </p:blipFill>
        <p:spPr>
          <a:xfrm>
            <a:off x="1069903" y="3760234"/>
            <a:ext cx="2009715" cy="868486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1726487" y="3239897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1719Y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107120" y="3239897"/>
            <a:ext cx="683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1719W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335429" y="3239897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1720Y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012324" y="3505719"/>
            <a:ext cx="2047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M 1  2   3  4 M 1  2   3  4 M 1  2   3  4</a:t>
            </a:r>
            <a:endParaRPr lang="en-US" sz="1000" dirty="0"/>
          </a:p>
        </p:txBody>
      </p:sp>
      <p:sp>
        <p:nvSpPr>
          <p:cNvPr id="37" name="Right Brace 36"/>
          <p:cNvSpPr/>
          <p:nvPr/>
        </p:nvSpPr>
        <p:spPr>
          <a:xfrm rot="16200000">
            <a:off x="1403011" y="3285451"/>
            <a:ext cx="132492" cy="467999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38" name="Right Brace 37"/>
          <p:cNvSpPr/>
          <p:nvPr/>
        </p:nvSpPr>
        <p:spPr>
          <a:xfrm rot="16200000">
            <a:off x="2016560" y="3303451"/>
            <a:ext cx="132492" cy="431999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39" name="Right Brace 38"/>
          <p:cNvSpPr/>
          <p:nvPr/>
        </p:nvSpPr>
        <p:spPr>
          <a:xfrm rot="16200000">
            <a:off x="2641050" y="3303451"/>
            <a:ext cx="132492" cy="431999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pic>
        <p:nvPicPr>
          <p:cNvPr id="42" name="Picture 41" descr="TB5_endo_RTPCRs.TI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5" t="57903" r="8011" b="12699"/>
          <a:stretch/>
        </p:blipFill>
        <p:spPr>
          <a:xfrm>
            <a:off x="3123812" y="3751436"/>
            <a:ext cx="3371478" cy="877284"/>
          </a:xfrm>
          <a:prstGeom prst="rect">
            <a:avLst/>
          </a:prstGeom>
        </p:spPr>
      </p:pic>
      <p:grpSp>
        <p:nvGrpSpPr>
          <p:cNvPr id="43" name="Group 42"/>
          <p:cNvGrpSpPr/>
          <p:nvPr/>
        </p:nvGrpSpPr>
        <p:grpSpPr>
          <a:xfrm>
            <a:off x="3162077" y="3250238"/>
            <a:ext cx="3313728" cy="509996"/>
            <a:chOff x="1598688" y="958956"/>
            <a:chExt cx="3313728" cy="509996"/>
          </a:xfrm>
        </p:grpSpPr>
        <p:grpSp>
          <p:nvGrpSpPr>
            <p:cNvPr id="44" name="Group 43"/>
            <p:cNvGrpSpPr/>
            <p:nvPr/>
          </p:nvGrpSpPr>
          <p:grpSpPr>
            <a:xfrm>
              <a:off x="1766001" y="958956"/>
              <a:ext cx="3049487" cy="246221"/>
              <a:chOff x="1327146" y="248109"/>
              <a:chExt cx="3049487" cy="246221"/>
            </a:xfrm>
          </p:grpSpPr>
          <p:sp>
            <p:nvSpPr>
              <p:cNvPr id="51" name="TextBox 50"/>
              <p:cNvSpPr txBox="1"/>
              <p:nvPr/>
            </p:nvSpPr>
            <p:spPr>
              <a:xfrm>
                <a:off x="1327146" y="248109"/>
                <a:ext cx="6480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D1758V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1893279" y="248109"/>
                <a:ext cx="65523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G1762S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3111238" y="248109"/>
                <a:ext cx="6480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Y1700C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2500227" y="248109"/>
                <a:ext cx="6480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S1722C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728536" y="248109"/>
                <a:ext cx="6480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Y1699D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45" name="TextBox 44"/>
            <p:cNvSpPr txBox="1"/>
            <p:nvPr/>
          </p:nvSpPr>
          <p:spPr>
            <a:xfrm>
              <a:off x="1598688" y="1222731"/>
              <a:ext cx="33137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M  1  2  3  4 M 1  2   3  4 M 1  2   3  4 M 1  2   3  4 M 1  2   3  4</a:t>
              </a:r>
              <a:endParaRPr lang="en-US" sz="1000" dirty="0"/>
            </a:p>
          </p:txBody>
        </p:sp>
        <p:sp>
          <p:nvSpPr>
            <p:cNvPr id="46" name="Right Brace 45"/>
            <p:cNvSpPr/>
            <p:nvPr/>
          </p:nvSpPr>
          <p:spPr>
            <a:xfrm rot="16200000">
              <a:off x="2012358" y="1033574"/>
              <a:ext cx="132492" cy="409871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7" name="Right Brace 46"/>
            <p:cNvSpPr/>
            <p:nvPr/>
          </p:nvSpPr>
          <p:spPr>
            <a:xfrm rot="16200000">
              <a:off x="2618333" y="1012867"/>
              <a:ext cx="132492" cy="451285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8" name="Right Brace 47"/>
            <p:cNvSpPr/>
            <p:nvPr/>
          </p:nvSpPr>
          <p:spPr>
            <a:xfrm rot="16200000">
              <a:off x="3243329" y="1004510"/>
              <a:ext cx="132492" cy="467999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9" name="Right Brace 48"/>
            <p:cNvSpPr/>
            <p:nvPr/>
          </p:nvSpPr>
          <p:spPr>
            <a:xfrm rot="16200000">
              <a:off x="3856878" y="1022510"/>
              <a:ext cx="132492" cy="431999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0" name="Right Brace 49"/>
            <p:cNvSpPr/>
            <p:nvPr/>
          </p:nvSpPr>
          <p:spPr>
            <a:xfrm rot="16200000">
              <a:off x="4481368" y="1022510"/>
              <a:ext cx="132492" cy="431999"/>
            </a:xfrm>
            <a:prstGeom prst="rightBrac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sp>
        <p:nvSpPr>
          <p:cNvPr id="56" name="TextBox 55"/>
          <p:cNvSpPr txBox="1"/>
          <p:nvPr/>
        </p:nvSpPr>
        <p:spPr>
          <a:xfrm>
            <a:off x="759887" y="3185354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B</a:t>
            </a:r>
            <a:r>
              <a:rPr lang="en-US" sz="1000" b="1" dirty="0" smtClean="0">
                <a:latin typeface="Arial"/>
                <a:cs typeface="Arial"/>
              </a:rPr>
              <a:t>.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57" name="Picture 56" descr="TB5 recomb RTPCRs.TI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884" t="26100" r="7524" b="44244"/>
          <a:stretch/>
        </p:blipFill>
        <p:spPr>
          <a:xfrm>
            <a:off x="1069902" y="4653780"/>
            <a:ext cx="2009717" cy="902348"/>
          </a:xfrm>
          <a:prstGeom prst="rect">
            <a:avLst/>
          </a:prstGeom>
        </p:spPr>
      </p:pic>
      <p:pic>
        <p:nvPicPr>
          <p:cNvPr id="58" name="Picture 57" descr="TB5 recomb RTPCRs.TI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4" t="54865" r="8017" b="15687"/>
          <a:stretch/>
        </p:blipFill>
        <p:spPr>
          <a:xfrm>
            <a:off x="3123813" y="4662143"/>
            <a:ext cx="3383666" cy="896003"/>
          </a:xfrm>
          <a:prstGeom prst="rect">
            <a:avLst/>
          </a:prstGeom>
        </p:spPr>
      </p:pic>
      <p:sp>
        <p:nvSpPr>
          <p:cNvPr id="59" name="TextBox 58"/>
          <p:cNvSpPr txBox="1"/>
          <p:nvPr/>
        </p:nvSpPr>
        <p:spPr>
          <a:xfrm>
            <a:off x="667966" y="4009429"/>
            <a:ext cx="443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bn1</a:t>
            </a:r>
            <a:endParaRPr lang="en-US" sz="1000" dirty="0"/>
          </a:p>
        </p:txBody>
      </p:sp>
      <p:sp>
        <p:nvSpPr>
          <p:cNvPr id="60" name="TextBox 59"/>
          <p:cNvSpPr txBox="1"/>
          <p:nvPr/>
        </p:nvSpPr>
        <p:spPr>
          <a:xfrm>
            <a:off x="605537" y="4930621"/>
            <a:ext cx="505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usion</a:t>
            </a:r>
            <a:endParaRPr lang="en-US" sz="1000" dirty="0"/>
          </a:p>
        </p:txBody>
      </p:sp>
      <p:sp>
        <p:nvSpPr>
          <p:cNvPr id="63" name="TextBox 62"/>
          <p:cNvSpPr txBox="1"/>
          <p:nvPr/>
        </p:nvSpPr>
        <p:spPr>
          <a:xfrm>
            <a:off x="3803887" y="9006402"/>
            <a:ext cx="242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3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1023061" y="5818009"/>
            <a:ext cx="5202243" cy="3416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3:</a:t>
            </a:r>
            <a:endParaRPr lang="en-GB" sz="1200" dirty="0"/>
          </a:p>
          <a:p>
            <a:pPr algn="just"/>
            <a:r>
              <a:rPr lang="en-GB" sz="1200" dirty="0"/>
              <a:t>Semi-quantitative RT-PCR analysis of pooled MSU-1.1 fibroblast clones. Pools of clones were grown to 80% confluence in 25 cm</a:t>
            </a:r>
            <a:r>
              <a:rPr lang="en-GB" sz="1200" baseline="30000" dirty="0"/>
              <a:t>2</a:t>
            </a:r>
            <a:r>
              <a:rPr lang="en-GB" sz="1200" dirty="0"/>
              <a:t> tissue culture flasks using and total RNA was extracted using the </a:t>
            </a:r>
            <a:r>
              <a:rPr lang="en-GB" sz="1200" dirty="0" err="1"/>
              <a:t>RNeasy</a:t>
            </a:r>
            <a:r>
              <a:rPr lang="en-GB" sz="1200" dirty="0"/>
              <a:t> Mini kit (</a:t>
            </a:r>
            <a:r>
              <a:rPr lang="en-GB" sz="1200" dirty="0" err="1"/>
              <a:t>Qiagen</a:t>
            </a:r>
            <a:r>
              <a:rPr lang="en-GB" sz="1200" dirty="0"/>
              <a:t>). RT-PCR reactions were carried out using primer cb24rev (5'-</a:t>
            </a:r>
            <a:r>
              <a:rPr lang="nb-NO" sz="1200" dirty="0"/>
              <a:t> CATGCAATTATTTCCCCCATTCACTTGCATG</a:t>
            </a:r>
            <a:r>
              <a:rPr lang="en-GB" sz="1200" dirty="0"/>
              <a:t> -3') for first strand synthesis. Primers Fib1.21 (5'-TTGTGAAACCTTCTGCACAA-3') and Fib1.30 (5'-CAGAATATCCTCCCCCACCC-3') were used to selectively amplify material from endogenous </a:t>
            </a:r>
            <a:r>
              <a:rPr lang="en-GB" sz="1200" i="1" dirty="0"/>
              <a:t>FBN1</a:t>
            </a:r>
            <a:r>
              <a:rPr lang="en-GB" sz="1200" dirty="0"/>
              <a:t> and recombinant transcripts, respectively, using </a:t>
            </a:r>
            <a:r>
              <a:rPr lang="en-GB" sz="1200" dirty="0" err="1"/>
              <a:t>Taq</a:t>
            </a:r>
            <a:r>
              <a:rPr lang="en-GB" sz="1200" dirty="0"/>
              <a:t> DNA polymerase. 20, 25 or 30 cycles of denaturation at 95 °C (1 min), annealing at 60 °C (1 min) and extension at 72 °C (1 min), with a final extension step of 10 min were carried out. Comparable levels of recombinant transcript were seen in each case, except the MSU-1.1 control. Endogenous </a:t>
            </a:r>
            <a:r>
              <a:rPr lang="en-GB" sz="1200" i="1" dirty="0"/>
              <a:t>FBN1</a:t>
            </a:r>
            <a:r>
              <a:rPr lang="en-GB" sz="1200" dirty="0"/>
              <a:t> transcript levels were assessed as an internal control for variations in the amounts of starting material used in each of the reactions. </a:t>
            </a:r>
          </a:p>
          <a:p>
            <a:pPr algn="just"/>
            <a:r>
              <a:rPr lang="en-GB" sz="1200" dirty="0"/>
              <a:t> </a:t>
            </a:r>
          </a:p>
          <a:p>
            <a:pPr algn="just"/>
            <a:r>
              <a:rPr lang="en-GB" sz="1200" dirty="0"/>
              <a:t> </a:t>
            </a:r>
          </a:p>
          <a:p>
            <a:pPr algn="just"/>
            <a:r>
              <a:rPr lang="en-GB" sz="1200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1766428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723</Words>
  <Application>Microsoft Macintosh PowerPoint</Application>
  <PresentationFormat>A4 Paper (210x297 mm)</PresentationFormat>
  <Paragraphs>5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a Jensen</dc:creator>
  <cp:lastModifiedBy>Sacha Jensen</cp:lastModifiedBy>
  <cp:revision>6</cp:revision>
  <dcterms:created xsi:type="dcterms:W3CDTF">2014-09-17T16:17:14Z</dcterms:created>
  <dcterms:modified xsi:type="dcterms:W3CDTF">2015-03-09T16:53:41Z</dcterms:modified>
</cp:coreProperties>
</file>